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3" autoAdjust="0"/>
    <p:restoredTop sz="94660"/>
  </p:normalViewPr>
  <p:slideViewPr>
    <p:cSldViewPr snapToGrid="0">
      <p:cViewPr varScale="1">
        <p:scale>
          <a:sx n="86" d="100"/>
          <a:sy n="86" d="100"/>
        </p:scale>
        <p:origin x="138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881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550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3078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552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984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655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532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684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810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217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762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D9B04B-9EA7-4ADC-9330-E347E5AA2517}" type="datetimeFigureOut">
              <a:rPr lang="en-US" smtClean="0"/>
              <a:t>9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352FF6-1DCA-4680-A243-5305B22859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2215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TextBox 54"/>
          <p:cNvSpPr txBox="1"/>
          <p:nvPr/>
        </p:nvSpPr>
        <p:spPr>
          <a:xfrm>
            <a:off x="19204" y="5900708"/>
            <a:ext cx="912479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Peritoneal carcinomatosis index in each condition, as detailed in FIGURE 5, was determined based on the size, number, and distribution of lesions in the abdominal cavity as described before [117]. Data plotted as box plots using Th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BoxPlot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software [114] and statistically analyzed with Mann Whitney U test. *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&lt;0.05.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59" t="10456" r="6833" b="29593"/>
          <a:stretch/>
        </p:blipFill>
        <p:spPr>
          <a:xfrm>
            <a:off x="1962615" y="1170877"/>
            <a:ext cx="5898996" cy="3423425"/>
          </a:xfrm>
          <a:prstGeom prst="rect">
            <a:avLst/>
          </a:prstGeom>
        </p:spPr>
      </p:pic>
      <p:sp>
        <p:nvSpPr>
          <p:cNvPr id="56" name="TextBox 55"/>
          <p:cNvSpPr txBox="1"/>
          <p:nvPr/>
        </p:nvSpPr>
        <p:spPr>
          <a:xfrm rot="16200000">
            <a:off x="-412321" y="2360931"/>
            <a:ext cx="333421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Peritoneal carcinomatosis index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256157" y="2051825"/>
            <a:ext cx="468351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1.0         0.4         0.5            0</a:t>
            </a:r>
          </a:p>
        </p:txBody>
      </p:sp>
      <p:grpSp>
        <p:nvGrpSpPr>
          <p:cNvPr id="10" name="Group 9"/>
          <p:cNvGrpSpPr>
            <a:grpSpLocks noChangeAspect="1"/>
          </p:cNvGrpSpPr>
          <p:nvPr/>
        </p:nvGrpSpPr>
        <p:grpSpPr>
          <a:xfrm>
            <a:off x="3596814" y="1170876"/>
            <a:ext cx="4002198" cy="1036463"/>
            <a:chOff x="5935057" y="354340"/>
            <a:chExt cx="1600879" cy="414585"/>
          </a:xfrm>
        </p:grpSpPr>
        <p:grpSp>
          <p:nvGrpSpPr>
            <p:cNvPr id="62" name="Group 61"/>
            <p:cNvGrpSpPr/>
            <p:nvPr/>
          </p:nvGrpSpPr>
          <p:grpSpPr>
            <a:xfrm>
              <a:off x="5935057" y="354340"/>
              <a:ext cx="1446383" cy="109455"/>
              <a:chOff x="691763" y="7635120"/>
              <a:chExt cx="1446383" cy="174391"/>
            </a:xfrm>
          </p:grpSpPr>
          <p:cxnSp>
            <p:nvCxnSpPr>
              <p:cNvPr id="67" name="Straight Connector 66"/>
              <p:cNvCxnSpPr/>
              <p:nvPr/>
            </p:nvCxnSpPr>
            <p:spPr>
              <a:xfrm>
                <a:off x="691763" y="7635120"/>
                <a:ext cx="1446383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67"/>
              <p:cNvCxnSpPr/>
              <p:nvPr/>
            </p:nvCxnSpPr>
            <p:spPr>
              <a:xfrm>
                <a:off x="2138146" y="7635120"/>
                <a:ext cx="0" cy="17306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/>
              <p:cNvCxnSpPr/>
              <p:nvPr/>
            </p:nvCxnSpPr>
            <p:spPr>
              <a:xfrm>
                <a:off x="1662390" y="7636449"/>
                <a:ext cx="0" cy="17306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/>
              <p:cNvCxnSpPr/>
              <p:nvPr/>
            </p:nvCxnSpPr>
            <p:spPr>
              <a:xfrm>
                <a:off x="1169411" y="7636450"/>
                <a:ext cx="0" cy="17306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63" name="TextBox 62"/>
            <p:cNvSpPr txBox="1"/>
            <p:nvPr/>
          </p:nvSpPr>
          <p:spPr>
            <a:xfrm>
              <a:off x="6269013" y="559637"/>
              <a:ext cx="295540" cy="209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6763321" y="545066"/>
              <a:ext cx="295540" cy="209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7240396" y="545060"/>
              <a:ext cx="295540" cy="2092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847358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</TotalTime>
  <Words>76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IC College of Pharmac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olina, Maria</dc:creator>
  <cp:lastModifiedBy>MDPI</cp:lastModifiedBy>
  <cp:revision>11</cp:revision>
  <dcterms:created xsi:type="dcterms:W3CDTF">2022-08-21T18:34:34Z</dcterms:created>
  <dcterms:modified xsi:type="dcterms:W3CDTF">2022-09-20T02:25:54Z</dcterms:modified>
</cp:coreProperties>
</file>